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Honokio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7776771797461525E-2"/>
          <c:y val="2.3837115546350911E-2"/>
          <c:w val="0.85063849560032567"/>
          <c:h val="0.753106293671073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aph!$D$22</c:f>
              <c:strCache>
                <c:ptCount val="1"/>
                <c:pt idx="0">
                  <c:v>400 µg/m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>
              <a:outerShdw blurRad="50800" dist="25400" dir="5400000" algn="ctr" rotWithShape="0">
                <a:schemeClr val="accent3"/>
              </a:outerShdw>
            </a:effectLst>
          </c:spPr>
          <c:invertIfNegative val="0"/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F. solani 96</c:v>
                </c:pt>
                <c:pt idx="8">
                  <c:v>F. solani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[1]Honokiol!$C$23:$C$37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682-468D-9911-443CE176C70C}"/>
            </c:ext>
          </c:extLst>
        </c:ser>
        <c:ser>
          <c:idx val="2"/>
          <c:order val="1"/>
          <c:tx>
            <c:strRef>
              <c:f>Graph!$F$22</c:f>
              <c:strCache>
                <c:ptCount val="1"/>
                <c:pt idx="0">
                  <c:v>200 µg/ml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bg1"/>
              </a:solidFill>
            </a:ln>
          </c:spPr>
          <c:invertIfNegative val="0"/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F. solani 96</c:v>
                </c:pt>
                <c:pt idx="8">
                  <c:v>F. solani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[1]Honokiol!$E$23:$E$37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682-468D-9911-443CE176C70C}"/>
            </c:ext>
          </c:extLst>
        </c:ser>
        <c:ser>
          <c:idx val="4"/>
          <c:order val="2"/>
          <c:tx>
            <c:strRef>
              <c:f>Graph!$H$22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>
              <a:outerShdw blurRad="50800" dist="50800" dir="5400000" algn="ctr" rotWithShape="0">
                <a:schemeClr val="accent2"/>
              </a:outerShdw>
            </a:effectLst>
          </c:spPr>
          <c:invertIfNegative val="0"/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F. solani 96</c:v>
                </c:pt>
                <c:pt idx="8">
                  <c:v>F. solani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[1]Honokiol!$G$23:$G$37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682-468D-9911-443CE176C70C}"/>
            </c:ext>
          </c:extLst>
        </c:ser>
        <c:ser>
          <c:idx val="6"/>
          <c:order val="3"/>
          <c:tx>
            <c:strRef>
              <c:f>Graph!$J$22</c:f>
              <c:strCache>
                <c:ptCount val="1"/>
                <c:pt idx="0">
                  <c:v>10µg/m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[1]Honokiol!$J$23:$J$37</c:f>
                <c:numCache>
                  <c:formatCode>General</c:formatCode>
                  <c:ptCount val="15"/>
                  <c:pt idx="0">
                    <c:v>8.9655187922582336</c:v>
                  </c:pt>
                  <c:pt idx="1">
                    <c:v>8.2478609884232252</c:v>
                  </c:pt>
                  <c:pt idx="2">
                    <c:v>7.9197072600822507</c:v>
                  </c:pt>
                  <c:pt idx="3">
                    <c:v>0</c:v>
                  </c:pt>
                  <c:pt idx="4">
                    <c:v>6.2258087916818861</c:v>
                  </c:pt>
                  <c:pt idx="5">
                    <c:v>3.8890019429141791</c:v>
                  </c:pt>
                  <c:pt idx="6">
                    <c:v>6.7222547056644926</c:v>
                  </c:pt>
                  <c:pt idx="7">
                    <c:v>5.9386342594499508</c:v>
                  </c:pt>
                  <c:pt idx="8">
                    <c:v>1.3274167053242898</c:v>
                  </c:pt>
                  <c:pt idx="9">
                    <c:v>0</c:v>
                  </c:pt>
                  <c:pt idx="10">
                    <c:v>1.9245008972987538</c:v>
                  </c:pt>
                  <c:pt idx="11">
                    <c:v>2.7169424432452964</c:v>
                  </c:pt>
                  <c:pt idx="12">
                    <c:v>3.1100614784526615</c:v>
                  </c:pt>
                  <c:pt idx="13">
                    <c:v>2.2802909791523032</c:v>
                  </c:pt>
                  <c:pt idx="14">
                    <c:v>3.6779350481709514</c:v>
                  </c:pt>
                </c:numCache>
              </c:numRef>
            </c:plus>
            <c:minus>
              <c:numRef>
                <c:f>[1]Honokiol!$J$23:$J$37</c:f>
                <c:numCache>
                  <c:formatCode>General</c:formatCode>
                  <c:ptCount val="15"/>
                  <c:pt idx="0">
                    <c:v>8.9655187922582336</c:v>
                  </c:pt>
                  <c:pt idx="1">
                    <c:v>8.2478609884232252</c:v>
                  </c:pt>
                  <c:pt idx="2">
                    <c:v>7.9197072600822507</c:v>
                  </c:pt>
                  <c:pt idx="3">
                    <c:v>0</c:v>
                  </c:pt>
                  <c:pt idx="4">
                    <c:v>6.2258087916818861</c:v>
                  </c:pt>
                  <c:pt idx="5">
                    <c:v>3.8890019429141791</c:v>
                  </c:pt>
                  <c:pt idx="6">
                    <c:v>6.7222547056644926</c:v>
                  </c:pt>
                  <c:pt idx="7">
                    <c:v>5.9386342594499508</c:v>
                  </c:pt>
                  <c:pt idx="8">
                    <c:v>1.3274167053242898</c:v>
                  </c:pt>
                  <c:pt idx="9">
                    <c:v>0</c:v>
                  </c:pt>
                  <c:pt idx="10">
                    <c:v>1.9245008972987538</c:v>
                  </c:pt>
                  <c:pt idx="11">
                    <c:v>2.7169424432452964</c:v>
                  </c:pt>
                  <c:pt idx="12">
                    <c:v>3.1100614784526615</c:v>
                  </c:pt>
                  <c:pt idx="13">
                    <c:v>2.2802909791523032</c:v>
                  </c:pt>
                  <c:pt idx="14">
                    <c:v>3.6779350481709514</c:v>
                  </c:pt>
                </c:numCache>
              </c:numRef>
            </c:minus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F. solani 96</c:v>
                </c:pt>
                <c:pt idx="8">
                  <c:v>F. solani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[1]Honokiol!$I$23:$I$37</c:f>
              <c:numCache>
                <c:formatCode>General</c:formatCode>
                <c:ptCount val="15"/>
                <c:pt idx="0">
                  <c:v>21.821462488129153</c:v>
                </c:pt>
                <c:pt idx="1">
                  <c:v>4.7619047619047619</c:v>
                </c:pt>
                <c:pt idx="2">
                  <c:v>18.424242424242422</c:v>
                </c:pt>
                <c:pt idx="3">
                  <c:v>0</c:v>
                </c:pt>
                <c:pt idx="4">
                  <c:v>19.907773386034254</c:v>
                </c:pt>
                <c:pt idx="5">
                  <c:v>26.59069325735992</c:v>
                </c:pt>
                <c:pt idx="6">
                  <c:v>43.831417624521073</c:v>
                </c:pt>
                <c:pt idx="7">
                  <c:v>37.274220032840724</c:v>
                </c:pt>
                <c:pt idx="8">
                  <c:v>38.259109311740893</c:v>
                </c:pt>
                <c:pt idx="9">
                  <c:v>0</c:v>
                </c:pt>
                <c:pt idx="10">
                  <c:v>24.444444444444443</c:v>
                </c:pt>
                <c:pt idx="11">
                  <c:v>36.86274509803922</c:v>
                </c:pt>
                <c:pt idx="12">
                  <c:v>20.808080808080806</c:v>
                </c:pt>
                <c:pt idx="13">
                  <c:v>36.918767507002805</c:v>
                </c:pt>
                <c:pt idx="14">
                  <c:v>31.7530864197530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682-468D-9911-443CE176C70C}"/>
            </c:ext>
          </c:extLst>
        </c:ser>
        <c:ser>
          <c:idx val="8"/>
          <c:order val="4"/>
          <c:tx>
            <c:strRef>
              <c:f>Graph!$L$22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[1]Honokiol!$L$23:$L$37</c:f>
                <c:numCache>
                  <c:formatCode>General</c:formatCode>
                  <c:ptCount val="15"/>
                  <c:pt idx="0">
                    <c:v>5.320341763174306</c:v>
                  </c:pt>
                  <c:pt idx="1">
                    <c:v>5.4301801508774474</c:v>
                  </c:pt>
                  <c:pt idx="2">
                    <c:v>2</c:v>
                  </c:pt>
                  <c:pt idx="3">
                    <c:v>6.8135211582124633</c:v>
                  </c:pt>
                  <c:pt idx="4">
                    <c:v>8.550036919831987</c:v>
                  </c:pt>
                  <c:pt idx="5">
                    <c:v>14.183866861677432</c:v>
                  </c:pt>
                  <c:pt idx="6">
                    <c:v>6.4660649979524498</c:v>
                  </c:pt>
                  <c:pt idx="7">
                    <c:v>1.8390621333827686</c:v>
                  </c:pt>
                  <c:pt idx="8">
                    <c:v>8.7052380150446478</c:v>
                  </c:pt>
                  <c:pt idx="9">
                    <c:v>3.9020246446442086</c:v>
                  </c:pt>
                  <c:pt idx="10">
                    <c:v>10</c:v>
                  </c:pt>
                  <c:pt idx="11">
                    <c:v>2.3773246378396413</c:v>
                  </c:pt>
                  <c:pt idx="12">
                    <c:v>3.2972504033678716</c:v>
                  </c:pt>
                  <c:pt idx="13">
                    <c:v>3.0822509139448568</c:v>
                  </c:pt>
                  <c:pt idx="14">
                    <c:v>40.11834345385514</c:v>
                  </c:pt>
                </c:numCache>
              </c:numRef>
            </c:plus>
            <c:minus>
              <c:numRef>
                <c:f>[1]Honokiol!$L$23:$L$37</c:f>
                <c:numCache>
                  <c:formatCode>General</c:formatCode>
                  <c:ptCount val="15"/>
                  <c:pt idx="0">
                    <c:v>5.320341763174306</c:v>
                  </c:pt>
                  <c:pt idx="1">
                    <c:v>5.4301801508774474</c:v>
                  </c:pt>
                  <c:pt idx="2">
                    <c:v>2</c:v>
                  </c:pt>
                  <c:pt idx="3">
                    <c:v>6.8135211582124633</c:v>
                  </c:pt>
                  <c:pt idx="4">
                    <c:v>8.550036919831987</c:v>
                  </c:pt>
                  <c:pt idx="5">
                    <c:v>14.183866861677432</c:v>
                  </c:pt>
                  <c:pt idx="6">
                    <c:v>6.4660649979524498</c:v>
                  </c:pt>
                  <c:pt idx="7">
                    <c:v>1.8390621333827686</c:v>
                  </c:pt>
                  <c:pt idx="8">
                    <c:v>8.7052380150446478</c:v>
                  </c:pt>
                  <c:pt idx="9">
                    <c:v>3.9020246446442086</c:v>
                  </c:pt>
                  <c:pt idx="10">
                    <c:v>10</c:v>
                  </c:pt>
                  <c:pt idx="11">
                    <c:v>2.3773246378396413</c:v>
                  </c:pt>
                  <c:pt idx="12">
                    <c:v>3.2972504033678716</c:v>
                  </c:pt>
                  <c:pt idx="13">
                    <c:v>3.0822509139448568</c:v>
                  </c:pt>
                  <c:pt idx="14">
                    <c:v>40.11834345385514</c:v>
                  </c:pt>
                </c:numCache>
              </c:numRef>
            </c:minus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F. solani 96</c:v>
                </c:pt>
                <c:pt idx="8">
                  <c:v>F. solani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[1]Honokiol!$K$23:$K$37</c:f>
              <c:numCache>
                <c:formatCode>General</c:formatCode>
                <c:ptCount val="15"/>
                <c:pt idx="0">
                  <c:v>61.646723646723643</c:v>
                </c:pt>
                <c:pt idx="1">
                  <c:v>68.042328042328037</c:v>
                </c:pt>
                <c:pt idx="2">
                  <c:v>50</c:v>
                </c:pt>
                <c:pt idx="3">
                  <c:v>63.840579710144929</c:v>
                </c:pt>
                <c:pt idx="4">
                  <c:v>75.698287220026359</c:v>
                </c:pt>
                <c:pt idx="5">
                  <c:v>69.420702754036071</c:v>
                </c:pt>
                <c:pt idx="6">
                  <c:v>80.602079912424742</c:v>
                </c:pt>
                <c:pt idx="7">
                  <c:v>81.403940886699516</c:v>
                </c:pt>
                <c:pt idx="8">
                  <c:v>55.735492577597846</c:v>
                </c:pt>
                <c:pt idx="9">
                  <c:v>69.610636277302945</c:v>
                </c:pt>
                <c:pt idx="10">
                  <c:v>60</c:v>
                </c:pt>
                <c:pt idx="11">
                  <c:v>62.156862745098046</c:v>
                </c:pt>
                <c:pt idx="12">
                  <c:v>61.356421356421357</c:v>
                </c:pt>
                <c:pt idx="13">
                  <c:v>55.350140056022411</c:v>
                </c:pt>
                <c:pt idx="14">
                  <c:v>46.2222222222222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2682-468D-9911-443CE176C70C}"/>
            </c:ext>
          </c:extLst>
        </c:ser>
        <c:ser>
          <c:idx val="1"/>
          <c:order val="5"/>
          <c:tx>
            <c:strRef>
              <c:f>Graph!$C$22</c:f>
              <c:strCache>
                <c:ptCount val="1"/>
                <c:pt idx="0">
                  <c:v>0 µg/ml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</c:spPr>
          <c:invertIfNegative val="0"/>
          <c:errBars>
            <c:errBarType val="plus"/>
            <c:errValType val="fixedVal"/>
            <c:noEndCap val="0"/>
            <c:val val="0"/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F. solani 96</c:v>
                </c:pt>
                <c:pt idx="8">
                  <c:v>F. solani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C$23:$C$37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2682-468D-9911-443CE176C7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7261144"/>
        <c:axId val="347261536"/>
      </c:barChart>
      <c:catAx>
        <c:axId val="3472611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47261536"/>
        <c:crosses val="autoZero"/>
        <c:auto val="1"/>
        <c:lblAlgn val="ctr"/>
        <c:lblOffset val="100"/>
        <c:noMultiLvlLbl val="0"/>
      </c:catAx>
      <c:valAx>
        <c:axId val="347261536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sz="800"/>
                  <a:t>Colony</a:t>
                </a:r>
                <a:r>
                  <a:rPr lang="en-GB" sz="800" baseline="0"/>
                  <a:t> diameter (% relative to control)</a:t>
                </a:r>
                <a:endParaRPr lang="en-GB" sz="800"/>
              </a:p>
            </c:rich>
          </c:tx>
          <c:layout>
            <c:manualLayout>
              <c:xMode val="edge"/>
              <c:yMode val="edge"/>
              <c:x val="6.1048752854986586E-3"/>
              <c:y val="0.30047958656264839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47261144"/>
        <c:crosses val="autoZero"/>
        <c:crossBetween val="between"/>
      </c:valAx>
    </c:plotArea>
    <c:legend>
      <c:legendPos val="r"/>
      <c:legendEntry>
        <c:idx val="1"/>
        <c:txPr>
          <a:bodyPr/>
          <a:lstStyle/>
          <a:p>
            <a:pPr>
              <a:defRPr sz="800" baseline="0">
                <a:ln>
                  <a:noFill/>
                </a:ln>
                <a:solidFill>
                  <a:sysClr val="windowText" lastClr="000000"/>
                </a:solidFill>
                <a:latin typeface="+mn-lt"/>
                <a:cs typeface="Times New Roman" panose="02020603050405020304" pitchFamily="18" charset="0"/>
              </a:defRPr>
            </a:pPr>
            <a:endParaRPr lang="it-IT"/>
          </a:p>
        </c:txPr>
      </c:legendEntry>
      <c:layout>
        <c:manualLayout>
          <c:xMode val="edge"/>
          <c:yMode val="edge"/>
          <c:x val="0.91601597801036627"/>
          <c:y val="0.38102784578637539"/>
          <c:w val="8.3984021989633825E-2"/>
          <c:h val="0.26972697274419782"/>
        </c:manualLayout>
      </c:layout>
      <c:overlay val="0"/>
      <c:spPr>
        <a:noFill/>
      </c:spPr>
      <c:txPr>
        <a:bodyPr/>
        <a:lstStyle/>
        <a:p>
          <a:pPr>
            <a:defRPr sz="800">
              <a:ln>
                <a:noFill/>
              </a:ln>
              <a:solidFill>
                <a:sysClr val="windowText" lastClr="000000"/>
              </a:solidFill>
              <a:latin typeface="+mn-lt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271</cdr:x>
      <cdr:y>0.55123</cdr:y>
    </cdr:from>
    <cdr:to>
      <cdr:x>0.10818</cdr:x>
      <cdr:y>0.61145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607489" y="3524252"/>
          <a:ext cx="296325" cy="3850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7904</cdr:x>
      <cdr:y>0.3228</cdr:y>
    </cdr:from>
    <cdr:to>
      <cdr:x>0.10117</cdr:x>
      <cdr:y>0.36942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660374" y="2063761"/>
          <a:ext cx="184885" cy="2980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9163</cdr:x>
      <cdr:y>0.11256</cdr:y>
    </cdr:from>
    <cdr:to>
      <cdr:x>0.13099</cdr:x>
      <cdr:y>0.14853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765503" y="719668"/>
          <a:ext cx="328811" cy="2299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3098</cdr:x>
      <cdr:y>0.66215</cdr:y>
    </cdr:from>
    <cdr:to>
      <cdr:x>0.15713</cdr:x>
      <cdr:y>0.71376</cdr:y>
    </cdr:to>
    <cdr:sp macro="" textlink="">
      <cdr:nvSpPr>
        <cdr:cNvPr id="5" name="CasellaDiTesto 4"/>
        <cdr:cNvSpPr txBox="1"/>
      </cdr:nvSpPr>
      <cdr:spPr>
        <a:xfrm xmlns:a="http://schemas.openxmlformats.org/drawingml/2006/main">
          <a:off x="1094282" y="4233354"/>
          <a:ext cx="218470" cy="3299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3613</cdr:x>
      <cdr:y>0.27856</cdr:y>
    </cdr:from>
    <cdr:to>
      <cdr:x>0.16391</cdr:x>
      <cdr:y>0.32372</cdr:y>
    </cdr:to>
    <cdr:sp macro="" textlink="">
      <cdr:nvSpPr>
        <cdr:cNvPr id="6" name="CasellaDiTesto 5"/>
        <cdr:cNvSpPr txBox="1"/>
      </cdr:nvSpPr>
      <cdr:spPr>
        <a:xfrm xmlns:a="http://schemas.openxmlformats.org/drawingml/2006/main">
          <a:off x="1137305" y="1780943"/>
          <a:ext cx="232087" cy="2887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4705</cdr:x>
      <cdr:y>0.10949</cdr:y>
    </cdr:from>
    <cdr:to>
      <cdr:x>0.17362</cdr:x>
      <cdr:y>0.14981</cdr:y>
    </cdr:to>
    <cdr:sp macro="" textlink="">
      <cdr:nvSpPr>
        <cdr:cNvPr id="7" name="CasellaDiTesto 6"/>
        <cdr:cNvSpPr txBox="1"/>
      </cdr:nvSpPr>
      <cdr:spPr>
        <a:xfrm xmlns:a="http://schemas.openxmlformats.org/drawingml/2006/main">
          <a:off x="1228563" y="700003"/>
          <a:ext cx="221978" cy="2577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8799</cdr:x>
      <cdr:y>0.58103</cdr:y>
    </cdr:from>
    <cdr:to>
      <cdr:x>0.216</cdr:x>
      <cdr:y>0.61543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1570542" y="3714762"/>
          <a:ext cx="234009" cy="2199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9433</cdr:x>
      <cdr:y>0.4155</cdr:y>
    </cdr:from>
    <cdr:to>
      <cdr:x>0.22101</cdr:x>
      <cdr:y>0.45612</cdr:y>
    </cdr:to>
    <cdr:sp macro="" textlink="">
      <cdr:nvSpPr>
        <cdr:cNvPr id="9" name="CasellaDiTesto 8"/>
        <cdr:cNvSpPr txBox="1"/>
      </cdr:nvSpPr>
      <cdr:spPr>
        <a:xfrm xmlns:a="http://schemas.openxmlformats.org/drawingml/2006/main">
          <a:off x="1623508" y="2656424"/>
          <a:ext cx="222898" cy="2596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049</cdr:x>
      <cdr:y>0.11091</cdr:y>
    </cdr:from>
    <cdr:to>
      <cdr:x>0.2488</cdr:x>
      <cdr:y>0.14505</cdr:y>
    </cdr:to>
    <cdr:sp macro="" textlink="">
      <cdr:nvSpPr>
        <cdr:cNvPr id="10" name="CasellaDiTesto 9"/>
        <cdr:cNvSpPr txBox="1"/>
      </cdr:nvSpPr>
      <cdr:spPr>
        <a:xfrm xmlns:a="http://schemas.openxmlformats.org/drawingml/2006/main">
          <a:off x="1711839" y="709084"/>
          <a:ext cx="366726" cy="21827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488</cdr:x>
      <cdr:y>0.29962</cdr:y>
    </cdr:from>
    <cdr:to>
      <cdr:x>0.28845</cdr:x>
      <cdr:y>0.35011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2078577" y="1915597"/>
          <a:ext cx="331255" cy="3228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6146</cdr:x>
      <cdr:y>0.11256</cdr:y>
    </cdr:from>
    <cdr:to>
      <cdr:x>0.30834</cdr:x>
      <cdr:y>0.16135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2184401" y="719668"/>
          <a:ext cx="391580" cy="3119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9947</cdr:x>
      <cdr:y>0.57772</cdr:y>
    </cdr:from>
    <cdr:to>
      <cdr:x>0.32702</cdr:x>
      <cdr:y>0.64366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2501926" y="3693570"/>
          <a:ext cx="230166" cy="4215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058</cdr:x>
      <cdr:y>0.21519</cdr:y>
    </cdr:from>
    <cdr:to>
      <cdr:x>0.3391</cdr:x>
      <cdr:y>0.25497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2554810" y="1375804"/>
          <a:ext cx="278204" cy="2543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1593</cdr:x>
      <cdr:y>0.11091</cdr:y>
    </cdr:from>
    <cdr:to>
      <cdr:x>0.35232</cdr:x>
      <cdr:y>0.15159</cdr:y>
    </cdr:to>
    <cdr:sp macro="" textlink="">
      <cdr:nvSpPr>
        <cdr:cNvPr id="15" name="CasellaDiTesto 14"/>
        <cdr:cNvSpPr txBox="1"/>
      </cdr:nvSpPr>
      <cdr:spPr>
        <a:xfrm xmlns:a="http://schemas.openxmlformats.org/drawingml/2006/main">
          <a:off x="2639468" y="709091"/>
          <a:ext cx="304019" cy="2600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552</cdr:x>
      <cdr:y>0.54792</cdr:y>
    </cdr:from>
    <cdr:to>
      <cdr:x>0.38751</cdr:x>
      <cdr:y>0.59624</cdr:y>
    </cdr:to>
    <cdr:sp macro="" textlink="">
      <cdr:nvSpPr>
        <cdr:cNvPr id="16" name="CasellaDiTesto 15"/>
        <cdr:cNvSpPr txBox="1"/>
      </cdr:nvSpPr>
      <cdr:spPr>
        <a:xfrm xmlns:a="http://schemas.openxmlformats.org/drawingml/2006/main">
          <a:off x="2967551" y="3503084"/>
          <a:ext cx="269933" cy="3089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50"/>
            <a:t>c</a:t>
          </a:r>
        </a:p>
      </cdr:txBody>
    </cdr:sp>
  </cdr:relSizeAnchor>
  <cdr:relSizeAnchor xmlns:cdr="http://schemas.openxmlformats.org/drawingml/2006/chartDrawing">
    <cdr:from>
      <cdr:x>0.36408</cdr:x>
      <cdr:y>0.22182</cdr:y>
    </cdr:from>
    <cdr:to>
      <cdr:x>0.39844</cdr:x>
      <cdr:y>0.25633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3041682" y="1418196"/>
          <a:ext cx="287060" cy="2206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742</cdr:x>
      <cdr:y>0.10925</cdr:y>
    </cdr:from>
    <cdr:to>
      <cdr:x>0.41728</cdr:x>
      <cdr:y>0.14191</cdr:y>
    </cdr:to>
    <cdr:sp macro="" textlink="">
      <cdr:nvSpPr>
        <cdr:cNvPr id="18" name="CasellaDiTesto 17"/>
        <cdr:cNvSpPr txBox="1"/>
      </cdr:nvSpPr>
      <cdr:spPr>
        <a:xfrm xmlns:a="http://schemas.openxmlformats.org/drawingml/2006/main">
          <a:off x="3126281" y="698501"/>
          <a:ext cx="359865" cy="2087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1348</cdr:x>
      <cdr:y>0.42046</cdr:y>
    </cdr:from>
    <cdr:to>
      <cdr:x>0.4599</cdr:x>
      <cdr:y>0.46758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3454393" y="2688160"/>
          <a:ext cx="387815" cy="3012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1981</cdr:x>
      <cdr:y>0.19698</cdr:y>
    </cdr:from>
    <cdr:to>
      <cdr:x>0.46226</cdr:x>
      <cdr:y>0.23862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3507304" y="1259399"/>
          <a:ext cx="354648" cy="2662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2995</cdr:x>
      <cdr:y>0.10925</cdr:y>
    </cdr:from>
    <cdr:to>
      <cdr:x>0.47555</cdr:x>
      <cdr:y>0.14998</cdr:y>
    </cdr:to>
    <cdr:sp macro="" textlink="">
      <cdr:nvSpPr>
        <cdr:cNvPr id="21" name="CasellaDiTesto 20"/>
        <cdr:cNvSpPr txBox="1"/>
      </cdr:nvSpPr>
      <cdr:spPr>
        <a:xfrm xmlns:a="http://schemas.openxmlformats.org/drawingml/2006/main">
          <a:off x="3592017" y="698501"/>
          <a:ext cx="380963" cy="2603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7555</cdr:x>
      <cdr:y>0.47509</cdr:y>
    </cdr:from>
    <cdr:to>
      <cdr:x>0.49432</cdr:x>
      <cdr:y>0.51766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3972980" y="3037417"/>
          <a:ext cx="156807" cy="2721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47429</cdr:x>
      <cdr:y>0.2152</cdr:y>
    </cdr:from>
    <cdr:to>
      <cdr:x>0.50923</cdr:x>
      <cdr:y>0.2613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3962426" y="1375828"/>
          <a:ext cx="291906" cy="2947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b</a:t>
          </a:r>
        </a:p>
      </cdr:txBody>
    </cdr:sp>
  </cdr:relSizeAnchor>
  <cdr:relSizeAnchor xmlns:cdr="http://schemas.openxmlformats.org/drawingml/2006/chartDrawing">
    <cdr:from>
      <cdr:x>0.48569</cdr:x>
      <cdr:y>0.10925</cdr:y>
    </cdr:from>
    <cdr:to>
      <cdr:x>0.53129</cdr:x>
      <cdr:y>0.14675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4057666" y="698501"/>
          <a:ext cx="380981" cy="2397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2116</cdr:x>
      <cdr:y>0.33273</cdr:y>
    </cdr:from>
    <cdr:to>
      <cdr:x>0.55964</cdr:x>
      <cdr:y>0.367</cdr:y>
    </cdr:to>
    <cdr:sp macro="" textlink="">
      <cdr:nvSpPr>
        <cdr:cNvPr id="26" name="CasellaDiTesto 25"/>
        <cdr:cNvSpPr txBox="1"/>
      </cdr:nvSpPr>
      <cdr:spPr>
        <a:xfrm xmlns:a="http://schemas.openxmlformats.org/drawingml/2006/main">
          <a:off x="4353981" y="2127251"/>
          <a:ext cx="321521" cy="2191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4269</cdr:x>
      <cdr:y>0.11257</cdr:y>
    </cdr:from>
    <cdr:to>
      <cdr:x>0.59501</cdr:x>
      <cdr:y>0.17761</cdr:y>
    </cdr:to>
    <cdr:sp macro="" textlink="">
      <cdr:nvSpPr>
        <cdr:cNvPr id="27" name="CasellaDiTesto 26"/>
        <cdr:cNvSpPr txBox="1"/>
      </cdr:nvSpPr>
      <cdr:spPr>
        <a:xfrm xmlns:a="http://schemas.openxmlformats.org/drawingml/2006/main">
          <a:off x="4533929" y="719683"/>
          <a:ext cx="437106" cy="4158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9083</cdr:x>
      <cdr:y>0.28141</cdr:y>
    </cdr:from>
    <cdr:to>
      <cdr:x>0.6313</cdr:x>
      <cdr:y>0.33029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4936060" y="1799169"/>
          <a:ext cx="338106" cy="3125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997</cdr:x>
      <cdr:y>0.10926</cdr:y>
    </cdr:from>
    <cdr:to>
      <cdr:x>0.64344</cdr:x>
      <cdr:y>0.15172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5010165" y="698517"/>
          <a:ext cx="365425" cy="2714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4023</cdr:x>
      <cdr:y>0.57937</cdr:y>
    </cdr:from>
    <cdr:to>
      <cdr:x>0.6869</cdr:x>
      <cdr:y>0.6437</cdr:y>
    </cdr:to>
    <cdr:sp macro="" textlink="">
      <cdr:nvSpPr>
        <cdr:cNvPr id="30" name="CasellaDiTesto 29"/>
        <cdr:cNvSpPr txBox="1"/>
      </cdr:nvSpPr>
      <cdr:spPr>
        <a:xfrm xmlns:a="http://schemas.openxmlformats.org/drawingml/2006/main">
          <a:off x="5348802" y="3704153"/>
          <a:ext cx="389904" cy="4112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4657</cdr:x>
      <cdr:y>0.30458</cdr:y>
    </cdr:from>
    <cdr:to>
      <cdr:x>0.70743</cdr:x>
      <cdr:y>0.371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5401739" y="1947304"/>
          <a:ext cx="508454" cy="4246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5797</cdr:x>
      <cdr:y>0.11422</cdr:y>
    </cdr:from>
    <cdr:to>
      <cdr:x>0.70984</cdr:x>
      <cdr:y>0.16318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5496980" y="730238"/>
          <a:ext cx="433347" cy="313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9724</cdr:x>
      <cdr:y>0.49495</cdr:y>
    </cdr:from>
    <cdr:to>
      <cdr:x>0.73997</cdr:x>
      <cdr:y>0.55636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5825066" y="3164418"/>
          <a:ext cx="357010" cy="392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0357</cdr:x>
      <cdr:y>0.33769</cdr:y>
    </cdr:from>
    <cdr:to>
      <cdr:x>0.75439</cdr:x>
      <cdr:y>0.3951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5877999" y="2158984"/>
          <a:ext cx="424575" cy="3670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1244</cdr:x>
      <cdr:y>0.10926</cdr:y>
    </cdr:from>
    <cdr:to>
      <cdr:x>0.76285</cdr:x>
      <cdr:y>0.14841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5952103" y="698512"/>
          <a:ext cx="421150" cy="2503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5298</cdr:x>
      <cdr:y>0.586</cdr:y>
    </cdr:from>
    <cdr:to>
      <cdr:x>0.80765</cdr:x>
      <cdr:y>0.68376</cdr:y>
    </cdr:to>
    <cdr:sp macro="" textlink="">
      <cdr:nvSpPr>
        <cdr:cNvPr id="36" name="CasellaDiTesto 35"/>
        <cdr:cNvSpPr txBox="1"/>
      </cdr:nvSpPr>
      <cdr:spPr>
        <a:xfrm xmlns:a="http://schemas.openxmlformats.org/drawingml/2006/main">
          <a:off x="6290741" y="3746527"/>
          <a:ext cx="456739" cy="6250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5931</cdr:x>
      <cdr:y>0.3377</cdr:y>
    </cdr:from>
    <cdr:to>
      <cdr:x>0.81356</cdr:x>
      <cdr:y>0.39676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6343678" y="2159019"/>
          <a:ext cx="453230" cy="3775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7071</cdr:x>
      <cdr:y>0.11587</cdr:y>
    </cdr:from>
    <cdr:to>
      <cdr:x>0.82334</cdr:x>
      <cdr:y>0.16644</cdr:y>
    </cdr:to>
    <cdr:sp macro="" textlink="">
      <cdr:nvSpPr>
        <cdr:cNvPr id="38" name="CasellaDiTesto 37"/>
        <cdr:cNvSpPr txBox="1"/>
      </cdr:nvSpPr>
      <cdr:spPr>
        <a:xfrm xmlns:a="http://schemas.openxmlformats.org/drawingml/2006/main">
          <a:off x="6438865" y="740821"/>
          <a:ext cx="439696" cy="3233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0998</cdr:x>
      <cdr:y>0.49661</cdr:y>
    </cdr:from>
    <cdr:to>
      <cdr:x>0.85829</cdr:x>
      <cdr:y>0.55968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6766972" y="3175027"/>
          <a:ext cx="403605" cy="4032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1505</cdr:x>
      <cdr:y>0.36749</cdr:y>
    </cdr:from>
    <cdr:to>
      <cdr:x>0.87043</cdr:x>
      <cdr:y>0.43227</cdr:y>
    </cdr:to>
    <cdr:sp macro="" textlink="">
      <cdr:nvSpPr>
        <cdr:cNvPr id="40" name="CasellaDiTesto 39"/>
        <cdr:cNvSpPr txBox="1"/>
      </cdr:nvSpPr>
      <cdr:spPr>
        <a:xfrm xmlns:a="http://schemas.openxmlformats.org/drawingml/2006/main">
          <a:off x="6809302" y="2349512"/>
          <a:ext cx="462671" cy="4141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b</a:t>
          </a:r>
        </a:p>
      </cdr:txBody>
    </cdr:sp>
  </cdr:relSizeAnchor>
  <cdr:relSizeAnchor xmlns:cdr="http://schemas.openxmlformats.org/drawingml/2006/chartDrawing">
    <cdr:from>
      <cdr:x>0.82645</cdr:x>
      <cdr:y>0.11588</cdr:y>
    </cdr:from>
    <cdr:to>
      <cdr:x>0.89458</cdr:x>
      <cdr:y>0.16623</cdr:y>
    </cdr:to>
    <cdr:sp macro="" textlink="">
      <cdr:nvSpPr>
        <cdr:cNvPr id="41" name="CasellaDiTesto 40"/>
        <cdr:cNvSpPr txBox="1"/>
      </cdr:nvSpPr>
      <cdr:spPr>
        <a:xfrm xmlns:a="http://schemas.openxmlformats.org/drawingml/2006/main">
          <a:off x="6904543" y="740841"/>
          <a:ext cx="569191" cy="3219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6572</cdr:x>
      <cdr:y>0.52309</cdr:y>
    </cdr:from>
    <cdr:to>
      <cdr:x>0.91625</cdr:x>
      <cdr:y>0.56621</cdr:y>
    </cdr:to>
    <cdr:sp macro="" textlink="">
      <cdr:nvSpPr>
        <cdr:cNvPr id="42" name="CasellaDiTesto 41"/>
        <cdr:cNvSpPr txBox="1"/>
      </cdr:nvSpPr>
      <cdr:spPr>
        <a:xfrm xmlns:a="http://schemas.openxmlformats.org/drawingml/2006/main">
          <a:off x="7232651" y="3344329"/>
          <a:ext cx="422152" cy="2756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7079</cdr:x>
      <cdr:y>0.19864</cdr:y>
    </cdr:from>
    <cdr:to>
      <cdr:x>0.93914</cdr:x>
      <cdr:y>0.25136</cdr:y>
    </cdr:to>
    <cdr:sp macro="" textlink="">
      <cdr:nvSpPr>
        <cdr:cNvPr id="43" name="CasellaDiTesto 42"/>
        <cdr:cNvSpPr txBox="1"/>
      </cdr:nvSpPr>
      <cdr:spPr>
        <a:xfrm xmlns:a="http://schemas.openxmlformats.org/drawingml/2006/main">
          <a:off x="7274978" y="1269988"/>
          <a:ext cx="571029" cy="3370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8219</cdr:x>
      <cdr:y>0.11588</cdr:y>
    </cdr:from>
    <cdr:to>
      <cdr:x>0.9427</cdr:x>
      <cdr:y>0.15333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7370219" y="740841"/>
          <a:ext cx="505530" cy="2394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2622</cdr:x>
      <cdr:y>0.48667</cdr:y>
    </cdr:from>
    <cdr:to>
      <cdr:x>0.56549</cdr:x>
      <cdr:y>0.55289</cdr:y>
    </cdr:to>
    <cdr:sp macro="" textlink="">
      <cdr:nvSpPr>
        <cdr:cNvPr id="45" name="TextBox 44"/>
        <cdr:cNvSpPr txBox="1"/>
      </cdr:nvSpPr>
      <cdr:spPr>
        <a:xfrm xmlns:a="http://schemas.openxmlformats.org/drawingml/2006/main">
          <a:off x="4396315" y="3111501"/>
          <a:ext cx="328053" cy="4233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c</a:t>
          </a:r>
        </a:p>
      </cdr:txBody>
    </cdr:sp>
  </cdr:relSizeAnchor>
  <cdr:relSizeAnchor xmlns:cdr="http://schemas.openxmlformats.org/drawingml/2006/chartDrawing">
    <cdr:from>
      <cdr:x>0.46921</cdr:x>
      <cdr:y>0.46516</cdr:y>
    </cdr:from>
    <cdr:to>
      <cdr:x>0.49581</cdr:x>
      <cdr:y>0.52806</cdr:y>
    </cdr:to>
    <cdr:sp macro="" textlink="">
      <cdr:nvSpPr>
        <cdr:cNvPr id="46" name="TextBox 45"/>
        <cdr:cNvSpPr txBox="1"/>
      </cdr:nvSpPr>
      <cdr:spPr>
        <a:xfrm xmlns:a="http://schemas.openxmlformats.org/drawingml/2006/main">
          <a:off x="3920045" y="2973920"/>
          <a:ext cx="222229" cy="4021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c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5903640" y="0"/>
            <a:ext cx="2772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smtClean="0"/>
              <a:t>Honokiol</a:t>
            </a:r>
            <a:r>
              <a:rPr lang="fr-FR" b="1" dirty="0" smtClean="0"/>
              <a:t> </a:t>
            </a:r>
            <a:r>
              <a:rPr lang="fr-FR" b="1" dirty="0" smtClean="0"/>
              <a:t>2</a:t>
            </a:r>
            <a:endParaRPr lang="en-GB" b="1" dirty="0"/>
          </a:p>
        </p:txBody>
      </p:sp>
      <p:graphicFrame>
        <p:nvGraphicFramePr>
          <p:cNvPr id="3" name="Grafico 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4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2212028"/>
              </p:ext>
            </p:extLst>
          </p:nvPr>
        </p:nvGraphicFramePr>
        <p:xfrm>
          <a:off x="539552" y="485964"/>
          <a:ext cx="8288130" cy="62724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7775833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4</TotalTime>
  <Words>52</Words>
  <Application>Microsoft Office PowerPoint</Application>
  <PresentationFormat>Presentazione su schermo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4</cp:revision>
  <dcterms:created xsi:type="dcterms:W3CDTF">2019-06-04T18:45:56Z</dcterms:created>
  <dcterms:modified xsi:type="dcterms:W3CDTF">2019-08-20T09:26:38Z</dcterms:modified>
</cp:coreProperties>
</file>